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6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E1FF"/>
    <a:srgbClr val="FFCCFF"/>
    <a:srgbClr val="FF99CC"/>
    <a:srgbClr val="FF6699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96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3:$B$21</c:f>
              <c:strCache>
                <c:ptCount val="19"/>
                <c:pt idx="0">
                  <c:v>24w</c:v>
                </c:pt>
                <c:pt idx="1">
                  <c:v>25w</c:v>
                </c:pt>
                <c:pt idx="2">
                  <c:v>26w</c:v>
                </c:pt>
                <c:pt idx="3">
                  <c:v>27w</c:v>
                </c:pt>
                <c:pt idx="4">
                  <c:v>28w</c:v>
                </c:pt>
                <c:pt idx="5">
                  <c:v>29w</c:v>
                </c:pt>
                <c:pt idx="6">
                  <c:v>30w</c:v>
                </c:pt>
                <c:pt idx="7">
                  <c:v>31w</c:v>
                </c:pt>
                <c:pt idx="8">
                  <c:v>32w</c:v>
                </c:pt>
                <c:pt idx="9">
                  <c:v>33w</c:v>
                </c:pt>
                <c:pt idx="10">
                  <c:v>34w</c:v>
                </c:pt>
                <c:pt idx="11">
                  <c:v>35w</c:v>
                </c:pt>
                <c:pt idx="12">
                  <c:v>36w</c:v>
                </c:pt>
                <c:pt idx="13">
                  <c:v>37w</c:v>
                </c:pt>
                <c:pt idx="14">
                  <c:v>38w</c:v>
                </c:pt>
                <c:pt idx="15">
                  <c:v>39w</c:v>
                </c:pt>
                <c:pt idx="16">
                  <c:v>40w</c:v>
                </c:pt>
                <c:pt idx="17">
                  <c:v>41w</c:v>
                </c:pt>
                <c:pt idx="18">
                  <c:v>42w</c:v>
                </c:pt>
              </c:strCache>
            </c:strRef>
          </c:cat>
          <c:val>
            <c:numRef>
              <c:f>Sheet1!$C$3:$C$21</c:f>
              <c:numCache>
                <c:formatCode>General</c:formatCode>
                <c:ptCount val="19"/>
                <c:pt idx="0">
                  <c:v>33</c:v>
                </c:pt>
                <c:pt idx="1">
                  <c:v>57</c:v>
                </c:pt>
                <c:pt idx="2">
                  <c:v>43</c:v>
                </c:pt>
                <c:pt idx="3">
                  <c:v>56</c:v>
                </c:pt>
                <c:pt idx="4">
                  <c:v>77</c:v>
                </c:pt>
                <c:pt idx="5">
                  <c:v>86</c:v>
                </c:pt>
                <c:pt idx="6">
                  <c:v>160</c:v>
                </c:pt>
                <c:pt idx="7">
                  <c:v>434</c:v>
                </c:pt>
                <c:pt idx="8">
                  <c:v>354</c:v>
                </c:pt>
                <c:pt idx="9">
                  <c:v>443</c:v>
                </c:pt>
                <c:pt idx="10">
                  <c:v>481</c:v>
                </c:pt>
                <c:pt idx="11">
                  <c:v>347</c:v>
                </c:pt>
                <c:pt idx="12">
                  <c:v>251</c:v>
                </c:pt>
                <c:pt idx="13">
                  <c:v>53</c:v>
                </c:pt>
                <c:pt idx="14">
                  <c:v>86</c:v>
                </c:pt>
                <c:pt idx="15">
                  <c:v>44</c:v>
                </c:pt>
                <c:pt idx="16">
                  <c:v>19</c:v>
                </c:pt>
                <c:pt idx="17">
                  <c:v>5</c:v>
                </c:pt>
                <c:pt idx="18">
                  <c:v>3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11D-46B2-91F0-F7B6F6A7F5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326682216"/>
        <c:axId val="324802448"/>
      </c:barChart>
      <c:lineChart>
        <c:grouping val="standard"/>
        <c:varyColors val="0"/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Sheet1!$B$3:$B$21</c:f>
              <c:strCache>
                <c:ptCount val="19"/>
                <c:pt idx="0">
                  <c:v>24w</c:v>
                </c:pt>
                <c:pt idx="1">
                  <c:v>25w</c:v>
                </c:pt>
                <c:pt idx="2">
                  <c:v>26w</c:v>
                </c:pt>
                <c:pt idx="3">
                  <c:v>27w</c:v>
                </c:pt>
                <c:pt idx="4">
                  <c:v>28w</c:v>
                </c:pt>
                <c:pt idx="5">
                  <c:v>29w</c:v>
                </c:pt>
                <c:pt idx="6">
                  <c:v>30w</c:v>
                </c:pt>
                <c:pt idx="7">
                  <c:v>31w</c:v>
                </c:pt>
                <c:pt idx="8">
                  <c:v>32w</c:v>
                </c:pt>
                <c:pt idx="9">
                  <c:v>33w</c:v>
                </c:pt>
                <c:pt idx="10">
                  <c:v>34w</c:v>
                </c:pt>
                <c:pt idx="11">
                  <c:v>35w</c:v>
                </c:pt>
                <c:pt idx="12">
                  <c:v>36w</c:v>
                </c:pt>
                <c:pt idx="13">
                  <c:v>37w</c:v>
                </c:pt>
                <c:pt idx="14">
                  <c:v>38w</c:v>
                </c:pt>
                <c:pt idx="15">
                  <c:v>39w</c:v>
                </c:pt>
                <c:pt idx="16">
                  <c:v>40w</c:v>
                </c:pt>
                <c:pt idx="17">
                  <c:v>41w</c:v>
                </c:pt>
                <c:pt idx="18">
                  <c:v>42w</c:v>
                </c:pt>
              </c:strCache>
            </c:strRef>
          </c:cat>
          <c:val>
            <c:numRef>
              <c:f>Sheet1!$D$3:$D$21</c:f>
              <c:numCache>
                <c:formatCode>0%</c:formatCode>
                <c:ptCount val="19"/>
                <c:pt idx="0">
                  <c:v>0</c:v>
                </c:pt>
                <c:pt idx="1">
                  <c:v>7.0175438596491224E-2</c:v>
                </c:pt>
                <c:pt idx="2">
                  <c:v>9.3023255813953487E-2</c:v>
                </c:pt>
                <c:pt idx="3">
                  <c:v>0.17857142857142858</c:v>
                </c:pt>
                <c:pt idx="4">
                  <c:v>0.27272727272727271</c:v>
                </c:pt>
                <c:pt idx="5">
                  <c:v>0.53488372093023251</c:v>
                </c:pt>
                <c:pt idx="6">
                  <c:v>0.66249999999999998</c:v>
                </c:pt>
                <c:pt idx="7">
                  <c:v>0.64746543778801846</c:v>
                </c:pt>
                <c:pt idx="8">
                  <c:v>0.82203389830508478</c:v>
                </c:pt>
                <c:pt idx="9">
                  <c:v>0.85553047404063209</c:v>
                </c:pt>
                <c:pt idx="10">
                  <c:v>0.91891891891891897</c:v>
                </c:pt>
                <c:pt idx="11">
                  <c:v>0.93083573487031701</c:v>
                </c:pt>
                <c:pt idx="12">
                  <c:v>0.98007968127490042</c:v>
                </c:pt>
                <c:pt idx="13">
                  <c:v>1</c:v>
                </c:pt>
                <c:pt idx="14">
                  <c:v>0.98837209302325579</c:v>
                </c:pt>
                <c:pt idx="15">
                  <c:v>0.88636363636363635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11D-46B2-91F0-F7B6F6A7F5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00876936"/>
        <c:axId val="400883600"/>
      </c:lineChart>
      <c:catAx>
        <c:axId val="3266822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+mn-cs"/>
              </a:defRPr>
            </a:pPr>
            <a:endParaRPr lang="ja-JP"/>
          </a:p>
        </c:txPr>
        <c:crossAx val="324802448"/>
        <c:crosses val="autoZero"/>
        <c:auto val="1"/>
        <c:lblAlgn val="ctr"/>
        <c:lblOffset val="0"/>
        <c:noMultiLvlLbl val="0"/>
      </c:catAx>
      <c:valAx>
        <c:axId val="324802448"/>
        <c:scaling>
          <c:orientation val="minMax"/>
          <c:max val="5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Meiryo UI" panose="020B0604030504040204" pitchFamily="50" charset="-128"/>
                    <a:ea typeface="Meiryo UI" panose="020B0604030504040204" pitchFamily="50" charset="-128"/>
                    <a:cs typeface="+mn-cs"/>
                  </a:defRPr>
                </a:pPr>
                <a:r>
                  <a:rPr lang="en-US" altLang="ja-JP" sz="1400" b="0" i="0" baseline="0" dirty="0">
                    <a:effectLst/>
                  </a:rPr>
                  <a:t>Number of L452R* mutation testing</a:t>
                </a:r>
                <a:endParaRPr lang="ja-JP" altLang="ja-JP" sz="1400" dirty="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Meiryo UI" panose="020B0604030504040204" pitchFamily="50" charset="-128"/>
                  <a:ea typeface="Meiryo UI" panose="020B0604030504040204" pitchFamily="50" charset="-128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+mn-cs"/>
              </a:defRPr>
            </a:pPr>
            <a:endParaRPr lang="ja-JP"/>
          </a:p>
        </c:txPr>
        <c:crossAx val="326682216"/>
        <c:crosses val="autoZero"/>
        <c:crossBetween val="between"/>
        <c:majorUnit val="100"/>
      </c:valAx>
      <c:valAx>
        <c:axId val="400883600"/>
        <c:scaling>
          <c:orientation val="minMax"/>
          <c:max val="1"/>
        </c:scaling>
        <c:delete val="0"/>
        <c:axPos val="r"/>
        <c:title>
          <c:tx>
            <c:rich>
              <a:bodyPr rot="5400000" spcFirstLastPara="1" vertOverflow="ellipsis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Meiryo UI" panose="020B0604030504040204" pitchFamily="50" charset="-128"/>
                    <a:ea typeface="Meiryo UI" panose="020B0604030504040204" pitchFamily="50" charset="-128"/>
                    <a:cs typeface="+mn-cs"/>
                  </a:defRPr>
                </a:pPr>
                <a:r>
                  <a:rPr lang="en-US" altLang="ja-JP" sz="1400" b="0" i="0" baseline="0" dirty="0">
                    <a:effectLst/>
                  </a:rPr>
                  <a:t>Percentage of L452R mutation</a:t>
                </a:r>
                <a:endParaRPr lang="ja-JP" altLang="ja-JP" sz="1400" dirty="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5400000" spcFirstLastPara="1" vertOverflow="ellipsis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Meiryo UI" panose="020B0604030504040204" pitchFamily="50" charset="-128"/>
                  <a:ea typeface="Meiryo UI" panose="020B0604030504040204" pitchFamily="50" charset="-128"/>
                  <a:cs typeface="+mn-cs"/>
                </a:defRPr>
              </a:pPr>
              <a:endParaRPr lang="ja-JP"/>
            </a:p>
          </c:txPr>
        </c:title>
        <c:numFmt formatCode="0%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+mn-cs"/>
              </a:defRPr>
            </a:pPr>
            <a:endParaRPr lang="ja-JP"/>
          </a:p>
        </c:txPr>
        <c:crossAx val="400876936"/>
        <c:crosses val="max"/>
        <c:crossBetween val="between"/>
        <c:majorUnit val="0.2"/>
      </c:valAx>
      <c:catAx>
        <c:axId val="40087693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40088360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800">
          <a:solidFill>
            <a:sysClr val="windowText" lastClr="000000"/>
          </a:solidFill>
          <a:latin typeface="Meiryo UI" panose="020B0604030504040204" pitchFamily="50" charset="-128"/>
          <a:ea typeface="Meiryo UI" panose="020B0604030504040204" pitchFamily="50" charset="-128"/>
        </a:defRPr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1BFFD3-6374-4F28-83B1-F9D114FD9AF8}" type="datetimeFigureOut">
              <a:rPr kumimoji="1" lang="ja-JP" altLang="en-US" smtClean="0"/>
              <a:t>2021/11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BB5C28-2BD0-4928-9A88-0F4DE689C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90467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E329B-2088-8F48-880F-0ABF24C485E2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11/11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8AE1A-20A2-A349-80DA-D70D0A9EBF83}" type="slidenum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969918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E329B-2088-8F48-880F-0ABF24C485E2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11/11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8AE1A-20A2-A349-80DA-D70D0A9EBF83}" type="slidenum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43246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E329B-2088-8F48-880F-0ABF24C485E2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11/11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8AE1A-20A2-A349-80DA-D70D0A9EBF83}" type="slidenum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409852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E329B-2088-8F48-880F-0ABF24C485E2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11/11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8AE1A-20A2-A349-80DA-D70D0A9EBF83}" type="slidenum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575679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E329B-2088-8F48-880F-0ABF24C485E2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11/11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8AE1A-20A2-A349-80DA-D70D0A9EBF83}" type="slidenum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89399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E329B-2088-8F48-880F-0ABF24C485E2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11/11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8AE1A-20A2-A349-80DA-D70D0A9EBF83}" type="slidenum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0806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E329B-2088-8F48-880F-0ABF24C485E2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11/11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8AE1A-20A2-A349-80DA-D70D0A9EBF83}" type="slidenum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817052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E329B-2088-8F48-880F-0ABF24C485E2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11/11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8AE1A-20A2-A349-80DA-D70D0A9EBF83}" type="slidenum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29752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E329B-2088-8F48-880F-0ABF24C485E2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11/11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8AE1A-20A2-A349-80DA-D70D0A9EBF83}" type="slidenum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591824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E329B-2088-8F48-880F-0ABF24C485E2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11/11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8AE1A-20A2-A349-80DA-D70D0A9EBF83}" type="slidenum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99181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E329B-2088-8F48-880F-0ABF24C485E2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11/11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8AE1A-20A2-A349-80DA-D70D0A9EBF83}" type="slidenum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484489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4E329B-2088-8F48-880F-0ABF24C485E2}" type="datetimeFigureOut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21/11/11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E8AE1A-20A2-A349-80DA-D70D0A9EBF83}" type="slidenum">
              <a:rPr kumimoji="1"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kumimoji="1"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385413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652C061C-7A66-48E3-B931-6F375A8A5E08}"/>
              </a:ext>
            </a:extLst>
          </p:cNvPr>
          <p:cNvGrpSpPr/>
          <p:nvPr/>
        </p:nvGrpSpPr>
        <p:grpSpPr>
          <a:xfrm>
            <a:off x="1437532" y="1123950"/>
            <a:ext cx="9316937" cy="5199825"/>
            <a:chOff x="1538718" y="281762"/>
            <a:chExt cx="9085548" cy="5836052"/>
          </a:xfrm>
        </p:grpSpPr>
        <p:graphicFrame>
          <p:nvGraphicFramePr>
            <p:cNvPr id="14" name="グラフ 13">
              <a:extLst>
                <a:ext uri="{FF2B5EF4-FFF2-40B4-BE49-F238E27FC236}">
                  <a16:creationId xmlns:a16="http://schemas.microsoft.com/office/drawing/2014/main" id="{00000000-0008-0000-0000-000003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93349710"/>
                </p:ext>
              </p:extLst>
            </p:nvPr>
          </p:nvGraphicFramePr>
          <p:xfrm>
            <a:off x="1538718" y="1180259"/>
            <a:ext cx="9085548" cy="493755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C80F4F29-2533-49B0-A816-A7A442F487F4}"/>
                </a:ext>
              </a:extLst>
            </p:cNvPr>
            <p:cNvSpPr txBox="1"/>
            <p:nvPr/>
          </p:nvSpPr>
          <p:spPr>
            <a:xfrm>
              <a:off x="5034201" y="858070"/>
              <a:ext cx="1552221" cy="5181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/>
                <a:t>N</a:t>
              </a:r>
              <a:r>
                <a:rPr kumimoji="1" lang="en-US" altLang="ja-JP" sz="1200" dirty="0"/>
                <a:t>asopharyngeal swab</a:t>
              </a:r>
            </a:p>
            <a:p>
              <a:pPr algn="ctr"/>
              <a:r>
                <a:rPr kumimoji="1" lang="en-US" altLang="ja-JP" sz="1200" dirty="0"/>
                <a:t>Collection period</a:t>
              </a:r>
              <a:endParaRPr kumimoji="1" lang="ja-JP" altLang="en-US" sz="1200" dirty="0"/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2538D01F-0E8C-4ADE-8310-701A8617DECB}"/>
                </a:ext>
              </a:extLst>
            </p:cNvPr>
            <p:cNvSpPr txBox="1"/>
            <p:nvPr/>
          </p:nvSpPr>
          <p:spPr>
            <a:xfrm>
              <a:off x="5136290" y="398008"/>
              <a:ext cx="2541914" cy="3108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/>
                <a:t>Anterior Nasal swab Collection period</a:t>
              </a:r>
            </a:p>
          </p:txBody>
        </p:sp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21606B98-FB48-430C-A589-CC710A1D712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71612" y="281762"/>
              <a:ext cx="0" cy="5459249"/>
            </a:xfrm>
            <a:prstGeom prst="line">
              <a:avLst/>
            </a:prstGeom>
            <a:ln w="190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id="{D5827BCB-1691-4E87-9DB0-ECF02185109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570406" y="783390"/>
              <a:ext cx="0" cy="4957621"/>
            </a:xfrm>
            <a:prstGeom prst="line">
              <a:avLst/>
            </a:prstGeom>
            <a:ln w="190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id="{3DE8210C-2983-4CBB-B72C-8CEAEF70B16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687303" y="281762"/>
              <a:ext cx="0" cy="5459250"/>
            </a:xfrm>
            <a:prstGeom prst="line">
              <a:avLst/>
            </a:prstGeom>
            <a:ln w="190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矢印コネクタ 15">
              <a:extLst>
                <a:ext uri="{FF2B5EF4-FFF2-40B4-BE49-F238E27FC236}">
                  <a16:creationId xmlns:a16="http://schemas.microsoft.com/office/drawing/2014/main" id="{90CC4337-66AD-4C3C-A079-180079E72A14}"/>
                </a:ext>
              </a:extLst>
            </p:cNvPr>
            <p:cNvCxnSpPr>
              <a:cxnSpLocks/>
            </p:cNvCxnSpPr>
            <p:nvPr/>
          </p:nvCxnSpPr>
          <p:spPr>
            <a:xfrm>
              <a:off x="5103951" y="868738"/>
              <a:ext cx="1422026" cy="0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triangle" w="lg" len="lg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矢印コネクタ 16">
              <a:extLst>
                <a:ext uri="{FF2B5EF4-FFF2-40B4-BE49-F238E27FC236}">
                  <a16:creationId xmlns:a16="http://schemas.microsoft.com/office/drawing/2014/main" id="{B93F44B8-F309-4323-A42C-32486C1C2541}"/>
                </a:ext>
              </a:extLst>
            </p:cNvPr>
            <p:cNvCxnSpPr>
              <a:cxnSpLocks/>
            </p:cNvCxnSpPr>
            <p:nvPr/>
          </p:nvCxnSpPr>
          <p:spPr>
            <a:xfrm>
              <a:off x="5103951" y="398008"/>
              <a:ext cx="2543606" cy="0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triangle" w="lg" len="lg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B0480A9-DAAA-49A0-B6A7-B2FBE2E91DD2}"/>
              </a:ext>
            </a:extLst>
          </p:cNvPr>
          <p:cNvSpPr txBox="1"/>
          <p:nvPr/>
        </p:nvSpPr>
        <p:spPr>
          <a:xfrm>
            <a:off x="6236829" y="6459115"/>
            <a:ext cx="5955171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Meiryo UI" panose="020B0604030504040204" pitchFamily="50" charset="-128"/>
                <a:ea typeface="Meiryo UI" panose="020B0604030504040204" pitchFamily="50" charset="-128"/>
              </a:rPr>
              <a:t>Adapted from Testing of SARS-CoV-2 variants at Ibaraki Prefectural Institute of Public Health</a:t>
            </a:r>
          </a:p>
          <a:p>
            <a:r>
              <a:rPr lang="ja-JP" altLang="en-US" sz="1000" dirty="0">
                <a:latin typeface="Meiryo UI" panose="020B0604030504040204" pitchFamily="50" charset="-128"/>
                <a:ea typeface="Meiryo UI" panose="020B0604030504040204" pitchFamily="50" charset="-128"/>
              </a:rPr>
              <a:t>https://www.pref.ibaraki.jp/hokenfukushi/eiken/kikaku/documents/henicorona2021-42.pdf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23F9C0B-FB33-4F85-B467-4492BB96E1AA}"/>
              </a:ext>
            </a:extLst>
          </p:cNvPr>
          <p:cNvSpPr txBox="1"/>
          <p:nvPr/>
        </p:nvSpPr>
        <p:spPr>
          <a:xfrm>
            <a:off x="6236829" y="6250764"/>
            <a:ext cx="41208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Meiryo UI" panose="020B0604030504040204" pitchFamily="50" charset="-128"/>
                <a:ea typeface="Meiryo UI" panose="020B0604030504040204" pitchFamily="50" charset="-128"/>
              </a:rPr>
              <a:t>*The L452R mutation is found in Delta, Kappa, Lambda, etc.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6DBFDB14-4A03-4E3B-AC2F-8847F78CB844}"/>
              </a:ext>
            </a:extLst>
          </p:cNvPr>
          <p:cNvSpPr txBox="1"/>
          <p:nvPr/>
        </p:nvSpPr>
        <p:spPr>
          <a:xfrm>
            <a:off x="383795" y="220079"/>
            <a:ext cx="11424410" cy="6870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20000"/>
              </a:lnSpc>
            </a:pPr>
            <a:r>
              <a:rPr kumimoji="1" lang="en-US" altLang="ja-JP" b="1" dirty="0">
                <a:latin typeface="Meiryo UI" panose="020B0604030504040204" pitchFamily="50" charset="-128"/>
                <a:ea typeface="Meiryo UI" panose="020B0604030504040204" pitchFamily="50" charset="-128"/>
              </a:rPr>
              <a:t>Supplementary Figure 1</a:t>
            </a:r>
            <a:r>
              <a:rPr lang="en-US" altLang="ja-JP" b="1" dirty="0">
                <a:latin typeface="Meiryo UI" panose="020B0604030504040204" pitchFamily="50" charset="-128"/>
                <a:ea typeface="Meiryo UI" panose="020B0604030504040204" pitchFamily="50" charset="-128"/>
              </a:rPr>
              <a:t>. </a:t>
            </a:r>
          </a:p>
          <a:p>
            <a:pPr>
              <a:lnSpc>
                <a:spcPct val="120000"/>
              </a:lnSpc>
            </a:pPr>
            <a:r>
              <a:rPr lang="en-US" altLang="ja-JP" sz="1600" dirty="0">
                <a:latin typeface="Meiryo UI" panose="020B0604030504040204" pitchFamily="50" charset="-128"/>
                <a:ea typeface="Meiryo UI" panose="020B0604030504040204" pitchFamily="50" charset="-128"/>
              </a:rPr>
              <a:t>Relationship between the study period and detection rate of mutant strains</a:t>
            </a:r>
            <a:r>
              <a:rPr lang="ja-JP" altLang="en-US" sz="1600" dirty="0">
                <a:latin typeface="Meiryo UI" panose="020B0604030504040204" pitchFamily="50" charset="-128"/>
                <a:ea typeface="Meiryo UI" panose="020B0604030504040204" pitchFamily="50" charset="-128"/>
              </a:rPr>
              <a:t> </a:t>
            </a:r>
            <a:r>
              <a:rPr lang="en-US" altLang="ja-JP" sz="1600" dirty="0">
                <a:latin typeface="Meiryo UI" panose="020B0604030504040204" pitchFamily="50" charset="-128"/>
                <a:ea typeface="Meiryo UI" panose="020B0604030504040204" pitchFamily="50" charset="-128"/>
              </a:rPr>
              <a:t>of</a:t>
            </a:r>
            <a:r>
              <a:rPr lang="ja-JP" altLang="en-US" sz="1600" dirty="0">
                <a:latin typeface="Meiryo UI" panose="020B0604030504040204" pitchFamily="50" charset="-128"/>
                <a:ea typeface="Meiryo UI" panose="020B0604030504040204" pitchFamily="50" charset="-128"/>
              </a:rPr>
              <a:t> </a:t>
            </a:r>
            <a:r>
              <a:rPr lang="en-US" altLang="ja-JP" sz="1600" dirty="0">
                <a:latin typeface="Meiryo UI" panose="020B0604030504040204" pitchFamily="50" charset="-128"/>
                <a:ea typeface="Meiryo UI" panose="020B0604030504040204" pitchFamily="50" charset="-128"/>
              </a:rPr>
              <a:t>SARS-CoV-2 in Ibaraki Prefecture</a:t>
            </a:r>
            <a:endParaRPr kumimoji="1" lang="ja-JP" altLang="en-US" sz="1600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751270357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087</TotalTime>
  <Words>91</Words>
  <Application>Microsoft Office PowerPoint</Application>
  <PresentationFormat>ワイド画面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Meiryo UI</vt:lpstr>
      <vt:lpstr>游ゴシック</vt:lpstr>
      <vt:lpstr>游ゴシック Light</vt:lpstr>
      <vt:lpstr>Arial</vt:lpstr>
      <vt:lpstr>Calibri</vt:lpstr>
      <vt:lpstr>Calibri Light</vt:lpstr>
      <vt:lpstr>1_Office 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加藤 大介 / Daisuke Kato</dc:creator>
  <cp:lastModifiedBy>筑波大学感染症科</cp:lastModifiedBy>
  <cp:revision>25</cp:revision>
  <cp:lastPrinted>2021-11-10T02:48:09Z</cp:lastPrinted>
  <dcterms:created xsi:type="dcterms:W3CDTF">2021-10-18T09:50:50Z</dcterms:created>
  <dcterms:modified xsi:type="dcterms:W3CDTF">2021-11-11T07:05:39Z</dcterms:modified>
</cp:coreProperties>
</file>